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4"/>
  </p:notesMasterIdLst>
  <p:sldIdLst>
    <p:sldId id="350" r:id="rId2"/>
    <p:sldId id="351" r:id="rId3"/>
  </p:sldIdLst>
  <p:sldSz cx="6858000" cy="9906000" type="A4"/>
  <p:notesSz cx="6797675" cy="992505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默认节" id="{BEF90C59-21DA-414D-8AC3-36642D00FC91}">
          <p14:sldIdLst/>
        </p14:section>
        <p14:section name="SI" id="{9D9778BF-2A10-44B7-8929-50C14FCF2C8C}">
          <p14:sldIdLst>
            <p14:sldId id="350"/>
            <p14:sldId id="351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3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00"/>
    <a:srgbClr val="3CB44B"/>
    <a:srgbClr val="E6194B"/>
    <a:srgbClr val="277632"/>
    <a:srgbClr val="9F044D"/>
    <a:srgbClr val="4C4C4F"/>
  </p:clrMru>
  <p:extLst>
    <p:ext uri="{E76CE94A-603C-4142-B9EB-6D1370010A27}">
      <p14:discardImageEditData xmlns:p14="http://schemas.microsoft.com/office/powerpoint/2010/main" val="1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058" autoAdjust="0"/>
    <p:restoredTop sz="92247" autoAdjust="0"/>
  </p:normalViewPr>
  <p:slideViewPr>
    <p:cSldViewPr showGuides="1">
      <p:cViewPr varScale="1">
        <p:scale>
          <a:sx n="111" d="100"/>
          <a:sy n="111" d="100"/>
        </p:scale>
        <p:origin x="4252" y="92"/>
      </p:cViewPr>
      <p:guideLst>
        <p:guide orient="horz" pos="3120"/>
        <p:guide pos="213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45000" cy="45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797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797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691264B-E3BD-4C3F-8264-4A59847D5462}" type="datetimeFigureOut">
              <a:rPr lang="zh-CN" altLang="en-US" smtClean="0"/>
              <a:t>2023/6/3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39838"/>
            <a:ext cx="2317750" cy="335121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79768" y="4776431"/>
            <a:ext cx="5438140" cy="390798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427076"/>
            <a:ext cx="2945659" cy="4979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50443" y="9427076"/>
            <a:ext cx="2945659" cy="4979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61892C9-0A8C-4D5A-BDA6-10C0B5F8B8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334629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zh-CN" altLang="en-US" dirty="0"/>
              <a:t>基于什么数据，</a:t>
            </a:r>
            <a:r>
              <a:rPr lang="en-US" altLang="zh-CN" dirty="0" err="1"/>
              <a:t>auc</a:t>
            </a:r>
            <a:r>
              <a:rPr lang="en-US" altLang="zh-CN" dirty="0"/>
              <a:t> &gt;0.7</a:t>
            </a:r>
            <a:r>
              <a:rPr lang="zh-CN" altLang="en-US" dirty="0"/>
              <a:t>用符号表示</a:t>
            </a:r>
            <a:r>
              <a:rPr lang="en-US" altLang="zh-CN" dirty="0"/>
              <a:t>, p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88F1CF2-CC17-4369-B6A4-13FE390298AC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574955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8E453-6D9D-430A-99D3-B2903D96C3E6}" type="datetimeFigureOut">
              <a:rPr lang="zh-CN" altLang="en-US" smtClean="0"/>
              <a:t>2023/6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C8D25-F24F-4F45-B312-D4614DFCDD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18012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8E453-6D9D-430A-99D3-B2903D96C3E6}" type="datetimeFigureOut">
              <a:rPr lang="zh-CN" altLang="en-US" smtClean="0"/>
              <a:t>2023/6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C8D25-F24F-4F45-B312-D4614DFCDD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721047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8E453-6D9D-430A-99D3-B2903D96C3E6}" type="datetimeFigureOut">
              <a:rPr lang="zh-CN" altLang="en-US" smtClean="0"/>
              <a:t>2023/6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C8D25-F24F-4F45-B312-D4614DFCDD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197009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8E453-6D9D-430A-99D3-B2903D96C3E6}" type="datetimeFigureOut">
              <a:rPr lang="zh-CN" altLang="en-US" smtClean="0"/>
              <a:t>2023/6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C8D25-F24F-4F45-B312-D4614DFCDD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18203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8E453-6D9D-430A-99D3-B2903D96C3E6}" type="datetimeFigureOut">
              <a:rPr lang="zh-CN" altLang="en-US" smtClean="0"/>
              <a:t>2023/6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C8D25-F24F-4F45-B312-D4614DFCDD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80541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8E453-6D9D-430A-99D3-B2903D96C3E6}" type="datetimeFigureOut">
              <a:rPr lang="zh-CN" altLang="en-US" smtClean="0"/>
              <a:t>2023/6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C8D25-F24F-4F45-B312-D4614DFCDD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721917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8E453-6D9D-430A-99D3-B2903D96C3E6}" type="datetimeFigureOut">
              <a:rPr lang="zh-CN" altLang="en-US" smtClean="0"/>
              <a:t>2023/6/3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C8D25-F24F-4F45-B312-D4614DFCDD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59477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8E453-6D9D-430A-99D3-B2903D96C3E6}" type="datetimeFigureOut">
              <a:rPr lang="zh-CN" altLang="en-US" smtClean="0"/>
              <a:t>2023/6/3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C8D25-F24F-4F45-B312-D4614DFCDD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349986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8E453-6D9D-430A-99D3-B2903D96C3E6}" type="datetimeFigureOut">
              <a:rPr lang="zh-CN" altLang="en-US" smtClean="0"/>
              <a:t>2023/6/3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C8D25-F24F-4F45-B312-D4614DFCDD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436966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8E453-6D9D-430A-99D3-B2903D96C3E6}" type="datetimeFigureOut">
              <a:rPr lang="zh-CN" altLang="en-US" smtClean="0"/>
              <a:t>2023/6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C8D25-F24F-4F45-B312-D4614DFCDD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112412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8E453-6D9D-430A-99D3-B2903D96C3E6}" type="datetimeFigureOut">
              <a:rPr lang="zh-CN" altLang="en-US" smtClean="0"/>
              <a:t>2023/6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C8D25-F24F-4F45-B312-D4614DFCDD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306164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D8E453-6D9D-430A-99D3-B2903D96C3E6}" type="datetimeFigureOut">
              <a:rPr lang="zh-CN" altLang="en-US" smtClean="0"/>
              <a:t>2023/6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0C8D25-F24F-4F45-B312-D4614DFCDD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33344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13347AC9-CDDC-34C1-C43B-D1BD1C7E5E44}"/>
              </a:ext>
            </a:extLst>
          </p:cNvPr>
          <p:cNvSpPr txBox="1"/>
          <p:nvPr/>
        </p:nvSpPr>
        <p:spPr>
          <a:xfrm>
            <a:off x="280988" y="2594431"/>
            <a:ext cx="6134100" cy="7155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Table S1. ROC curve analysis results from differential fecal metabolites of AMD detected in positive and negative ion mode calculated by linear SVM method. </a:t>
            </a:r>
            <a:endParaRPr lang="zh-CN" altLang="en-US" sz="1350" dirty="0"/>
          </a:p>
        </p:txBody>
      </p:sp>
      <p:graphicFrame>
        <p:nvGraphicFramePr>
          <p:cNvPr id="3" name="表格 2">
            <a:extLst>
              <a:ext uri="{FF2B5EF4-FFF2-40B4-BE49-F238E27FC236}">
                <a16:creationId xmlns:a16="http://schemas.microsoft.com/office/drawing/2014/main" id="{86ED0A98-D28D-066C-B5E7-42079A70F2B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11742928"/>
              </p:ext>
            </p:extLst>
          </p:nvPr>
        </p:nvGraphicFramePr>
        <p:xfrm>
          <a:off x="681037" y="3263947"/>
          <a:ext cx="5495928" cy="2742263"/>
        </p:xfrm>
        <a:graphic>
          <a:graphicData uri="http://schemas.openxmlformats.org/drawingml/2006/table">
            <a:tbl>
              <a:tblPr/>
              <a:tblGrid>
                <a:gridCol w="982664">
                  <a:extLst>
                    <a:ext uri="{9D8B030D-6E8A-4147-A177-3AD203B41FA5}">
                      <a16:colId xmlns:a16="http://schemas.microsoft.com/office/drawing/2014/main" val="4258409765"/>
                    </a:ext>
                  </a:extLst>
                </a:gridCol>
                <a:gridCol w="1580885">
                  <a:extLst>
                    <a:ext uri="{9D8B030D-6E8A-4147-A177-3AD203B41FA5}">
                      <a16:colId xmlns:a16="http://schemas.microsoft.com/office/drawing/2014/main" val="1940859231"/>
                    </a:ext>
                  </a:extLst>
                </a:gridCol>
                <a:gridCol w="403886">
                  <a:extLst>
                    <a:ext uri="{9D8B030D-6E8A-4147-A177-3AD203B41FA5}">
                      <a16:colId xmlns:a16="http://schemas.microsoft.com/office/drawing/2014/main" val="3273611821"/>
                    </a:ext>
                  </a:extLst>
                </a:gridCol>
                <a:gridCol w="842831">
                  <a:extLst>
                    <a:ext uri="{9D8B030D-6E8A-4147-A177-3AD203B41FA5}">
                      <a16:colId xmlns:a16="http://schemas.microsoft.com/office/drawing/2014/main" val="1604264656"/>
                    </a:ext>
                  </a:extLst>
                </a:gridCol>
                <a:gridCol w="842831">
                  <a:extLst>
                    <a:ext uri="{9D8B030D-6E8A-4147-A177-3AD203B41FA5}">
                      <a16:colId xmlns:a16="http://schemas.microsoft.com/office/drawing/2014/main" val="3981733752"/>
                    </a:ext>
                  </a:extLst>
                </a:gridCol>
                <a:gridCol w="842831">
                  <a:extLst>
                    <a:ext uri="{9D8B030D-6E8A-4147-A177-3AD203B41FA5}">
                      <a16:colId xmlns:a16="http://schemas.microsoft.com/office/drawing/2014/main" val="1155227378"/>
                    </a:ext>
                  </a:extLst>
                </a:gridCol>
              </a:tblGrid>
              <a:tr h="14097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Ion mode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Metabolites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AUC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SE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p–value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95% CI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82638517"/>
                  </a:ext>
                </a:extLst>
              </a:tr>
              <a:tr h="140971">
                <a:tc rowSpan="11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P</a:t>
                      </a:r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ositive</a:t>
                      </a:r>
                    </a:p>
                    <a:p>
                      <a:pPr algn="ctr" fontAlgn="ctr"/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ion</a:t>
                      </a:r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 mode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Palmitoyl </a:t>
                      </a:r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ethanolamide</a:t>
                      </a:r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★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838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072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001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697–0.979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79938693"/>
                  </a:ext>
                </a:extLst>
              </a:tr>
              <a:tr h="140971">
                <a:tc vMerge="1">
                  <a:txBody>
                    <a:bodyPr/>
                    <a:lstStyle/>
                    <a:p>
                      <a:pPr algn="ctr" fontAlgn="ctr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081" marR="5081" marT="50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Stearoyl </a:t>
                      </a:r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ethanolamide</a:t>
                      </a:r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★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79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078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004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638–0.943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05452460"/>
                  </a:ext>
                </a:extLst>
              </a:tr>
              <a:tr h="140971">
                <a:tc vMerge="1">
                  <a:txBody>
                    <a:bodyPr/>
                    <a:lstStyle/>
                    <a:p>
                      <a:pPr algn="ctr" fontAlgn="ctr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081" marR="5081" marT="50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Sphingosine★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765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09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009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588–0.941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95739376"/>
                  </a:ext>
                </a:extLst>
              </a:tr>
              <a:tr h="140971">
                <a:tc vMerge="1">
                  <a:txBody>
                    <a:bodyPr/>
                    <a:lstStyle/>
                    <a:p>
                      <a:pPr algn="ctr" fontAlgn="ctr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081" marR="5081" marT="50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Oleoyl </a:t>
                      </a:r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ethanolamide</a:t>
                      </a:r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★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746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085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016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579–0.913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69627156"/>
                  </a:ext>
                </a:extLst>
              </a:tr>
              <a:tr h="140971">
                <a:tc vMerge="1">
                  <a:txBody>
                    <a:bodyPr/>
                    <a:lstStyle/>
                    <a:p>
                      <a:pPr algn="ctr" fontAlgn="ctr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081" marR="5081" marT="50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N–</a:t>
                      </a:r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Acetylputrescine</a:t>
                      </a:r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★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735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088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021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564–0.907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61232714"/>
                  </a:ext>
                </a:extLst>
              </a:tr>
              <a:tr h="278131">
                <a:tc vMerge="1">
                  <a:txBody>
                    <a:bodyPr/>
                    <a:lstStyle/>
                    <a:p>
                      <a:pPr algn="ctr" fontAlgn="ctr"/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081" marR="5081" marT="50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–(14,15–</a:t>
                      </a:r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Epoxyeicosatrienoyl</a:t>
                      </a:r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) glycerol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482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103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857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28–0.683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57087110"/>
                  </a:ext>
                </a:extLst>
              </a:tr>
              <a:tr h="140971">
                <a:tc vMerge="1">
                  <a:txBody>
                    <a:bodyPr/>
                    <a:lstStyle/>
                    <a:p>
                      <a:pPr algn="ctr" fontAlgn="ctr"/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081" marR="5081" marT="50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5–</a:t>
                      </a:r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Hydroxyindoleacetic</a:t>
                      </a:r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 acid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415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102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407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216–0.615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98346768"/>
                  </a:ext>
                </a:extLst>
              </a:tr>
              <a:tr h="140971">
                <a:tc vMerge="1">
                  <a:txBody>
                    <a:bodyPr/>
                    <a:lstStyle/>
                    <a:p>
                      <a:pPr algn="ctr" fontAlgn="ctr"/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081" marR="5081" marT="50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N6,N6,N6–Trimethyl–L–lysine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375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101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221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177–0.573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45939749"/>
                  </a:ext>
                </a:extLst>
              </a:tr>
              <a:tr h="140971">
                <a:tc vMerge="1">
                  <a:txBody>
                    <a:bodyPr/>
                    <a:lstStyle/>
                    <a:p>
                      <a:pPr algn="ctr" fontAlgn="ctr"/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081" marR="5081" marT="50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Creatinine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467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104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746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264–0.67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80282552"/>
                  </a:ext>
                </a:extLst>
              </a:tr>
              <a:tr h="140971">
                <a:tc vMerge="1">
                  <a:txBody>
                    <a:bodyPr/>
                    <a:lstStyle/>
                    <a:p>
                      <a:pPr algn="ctr" fontAlgn="ctr"/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081" marR="5081" marT="50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Benzamide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463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103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719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262–0.664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50256575"/>
                  </a:ext>
                </a:extLst>
              </a:tr>
              <a:tr h="140971">
                <a:tc vMerge="1">
                  <a:txBody>
                    <a:bodyPr/>
                    <a:lstStyle/>
                    <a:p>
                      <a:pPr algn="ctr" fontAlgn="ctr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081" marR="5081" marT="50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Dimethylbenzimidazole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456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103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666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255–0.657</a:t>
                      </a:r>
                    </a:p>
                  </a:txBody>
                  <a:tcPr marL="3811" marR="3811" marT="38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66939714"/>
                  </a:ext>
                </a:extLst>
              </a:tr>
              <a:tr h="130493">
                <a:tc rowSpan="7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N</a:t>
                      </a:r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egative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 </a:t>
                      </a:r>
                    </a:p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ion 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mode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Uridine★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768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082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009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608–0.929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42417243"/>
                  </a:ext>
                </a:extLst>
              </a:tr>
              <a:tr h="130493">
                <a:tc vMerge="1"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Nicotinic acid★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761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086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011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593–0.929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22909300"/>
                  </a:ext>
                </a:extLst>
              </a:tr>
              <a:tr h="130493">
                <a:tc vMerge="1"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p–Anisic acid★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741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086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019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572–0.91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84657292"/>
                  </a:ext>
                </a:extLst>
              </a:tr>
              <a:tr h="130493">
                <a:tc vMerge="1"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D–Xylose★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746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085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016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579–0.914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17733975"/>
                  </a:ext>
                </a:extLst>
              </a:tr>
              <a:tr h="130493">
                <a:tc vMerge="1"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Glyceric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 acid★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746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088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016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574–0.918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0051337"/>
                  </a:ext>
                </a:extLst>
              </a:tr>
              <a:tr h="130493">
                <a:tc vMerge="1"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–</a:t>
                      </a:r>
                      <a:r>
                        <a:rPr lang="en-US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Methylbenzoic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 acid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305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091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056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126–0.484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72702312"/>
                  </a:ext>
                </a:extLst>
              </a:tr>
              <a:tr h="130493">
                <a:tc vMerge="1"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Chenodeoxycholic Acid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316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096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072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129–0.503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5510277"/>
                  </a:ext>
                </a:extLst>
              </a:tr>
            </a:tbl>
          </a:graphicData>
        </a:graphic>
      </p:graphicFrame>
      <p:sp>
        <p:nvSpPr>
          <p:cNvPr id="4" name="文本框 3">
            <a:extLst>
              <a:ext uri="{FF2B5EF4-FFF2-40B4-BE49-F238E27FC236}">
                <a16:creationId xmlns:a16="http://schemas.microsoft.com/office/drawing/2014/main" id="{1F3BCC43-D6E2-FEC4-E98C-E0A5D9BC1F60}"/>
              </a:ext>
            </a:extLst>
          </p:cNvPr>
          <p:cNvSpPr txBox="1"/>
          <p:nvPr/>
        </p:nvSpPr>
        <p:spPr>
          <a:xfrm>
            <a:off x="280988" y="6078000"/>
            <a:ext cx="6134100" cy="7155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Notes: AMD, age–related macular degeneration; ROC, receiver operating characteristic; SVM, support vector machine; AUC, area under the curve; CI, confidence interval.</a:t>
            </a:r>
          </a:p>
        </p:txBody>
      </p:sp>
    </p:spTree>
    <p:extLst>
      <p:ext uri="{BB962C8B-B14F-4D97-AF65-F5344CB8AC3E}">
        <p14:creationId xmlns:p14="http://schemas.microsoft.com/office/powerpoint/2010/main" val="15325744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>
            <a:extLst>
              <a:ext uri="{FF2B5EF4-FFF2-40B4-BE49-F238E27FC236}">
                <a16:creationId xmlns:a16="http://schemas.microsoft.com/office/drawing/2014/main" id="{111F765F-DF47-3E0A-7927-3744A36430E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71605890"/>
              </p:ext>
            </p:extLst>
          </p:nvPr>
        </p:nvGraphicFramePr>
        <p:xfrm>
          <a:off x="280987" y="3150096"/>
          <a:ext cx="6422232" cy="3910027"/>
        </p:xfrm>
        <a:graphic>
          <a:graphicData uri="http://schemas.openxmlformats.org/drawingml/2006/table">
            <a:tbl>
              <a:tblPr/>
              <a:tblGrid>
                <a:gridCol w="743903">
                  <a:extLst>
                    <a:ext uri="{9D8B030D-6E8A-4147-A177-3AD203B41FA5}">
                      <a16:colId xmlns:a16="http://schemas.microsoft.com/office/drawing/2014/main" val="3801132841"/>
                    </a:ext>
                  </a:extLst>
                </a:gridCol>
                <a:gridCol w="1613780">
                  <a:extLst>
                    <a:ext uri="{9D8B030D-6E8A-4147-A177-3AD203B41FA5}">
                      <a16:colId xmlns:a16="http://schemas.microsoft.com/office/drawing/2014/main" val="2591515899"/>
                    </a:ext>
                  </a:extLst>
                </a:gridCol>
                <a:gridCol w="918515">
                  <a:extLst>
                    <a:ext uri="{9D8B030D-6E8A-4147-A177-3AD203B41FA5}">
                      <a16:colId xmlns:a16="http://schemas.microsoft.com/office/drawing/2014/main" val="3683993405"/>
                    </a:ext>
                  </a:extLst>
                </a:gridCol>
                <a:gridCol w="1048678">
                  <a:extLst>
                    <a:ext uri="{9D8B030D-6E8A-4147-A177-3AD203B41FA5}">
                      <a16:colId xmlns:a16="http://schemas.microsoft.com/office/drawing/2014/main" val="3758865199"/>
                    </a:ext>
                  </a:extLst>
                </a:gridCol>
                <a:gridCol w="1048678">
                  <a:extLst>
                    <a:ext uri="{9D8B030D-6E8A-4147-A177-3AD203B41FA5}">
                      <a16:colId xmlns:a16="http://schemas.microsoft.com/office/drawing/2014/main" val="2417059736"/>
                    </a:ext>
                  </a:extLst>
                </a:gridCol>
                <a:gridCol w="1048678">
                  <a:extLst>
                    <a:ext uri="{9D8B030D-6E8A-4147-A177-3AD203B41FA5}">
                      <a16:colId xmlns:a16="http://schemas.microsoft.com/office/drawing/2014/main" val="659266712"/>
                    </a:ext>
                  </a:extLst>
                </a:gridCol>
              </a:tblGrid>
              <a:tr h="13049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Ion mode</a:t>
                      </a:r>
                      <a:endParaRPr lang="zh-CN" alt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Metabolites</a:t>
                      </a:r>
                      <a:endParaRPr lang="zh-CN" alt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AUC</a:t>
                      </a:r>
                      <a:endParaRPr lang="zh-CN" alt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SE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p–value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95% CI</a:t>
                      </a:r>
                      <a:endParaRPr lang="zh-CN" alt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48112716"/>
                  </a:ext>
                </a:extLst>
              </a:tr>
              <a:tr h="130493"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Positive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 </a:t>
                      </a:r>
                    </a:p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ion 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mode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4–Hydroxybenzoic acid</a:t>
                      </a:r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★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819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082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003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658–0.98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5748156"/>
                  </a:ext>
                </a:extLst>
              </a:tr>
              <a:tr h="130493">
                <a:tc vMerge="1"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–</a:t>
                      </a:r>
                      <a:r>
                        <a:rPr lang="en-US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Methylhistidine</a:t>
                      </a:r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★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762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092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016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581–0.942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83115798"/>
                  </a:ext>
                </a:extLst>
              </a:tr>
              <a:tr h="13049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Creatine</a:t>
                      </a:r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★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743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096</a:t>
                      </a:r>
                      <a:endParaRPr lang="en-US" altLang="zh-CN" sz="800" b="0" i="0" u="none" strike="noStrike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026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555–0.93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23238333"/>
                  </a:ext>
                </a:extLst>
              </a:tr>
              <a:tr h="13049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Inosine</a:t>
                      </a:r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★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724</a:t>
                      </a:r>
                      <a:endParaRPr lang="en-US" altLang="zh-CN" sz="800" b="0" i="0" u="none" strike="noStrike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096</a:t>
                      </a:r>
                      <a:endParaRPr lang="en-US" altLang="zh-CN" sz="800" b="0" i="0" u="none" strike="noStrike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04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536–0.911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99068301"/>
                  </a:ext>
                </a:extLst>
              </a:tr>
              <a:tr h="13049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C</a:t>
                      </a:r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affeine★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724</a:t>
                      </a:r>
                      <a:endParaRPr lang="en-US" altLang="zh-CN" sz="800" b="0" i="0" u="none" strike="noStrike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095</a:t>
                      </a:r>
                      <a:endParaRPr lang="en-US" altLang="zh-CN" sz="800" b="0" i="0" u="none" strike="noStrike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04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538–0.910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92031482"/>
                  </a:ext>
                </a:extLst>
              </a:tr>
              <a:tr h="130493">
                <a:tc vMerge="1"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Hypoxanthine</a:t>
                      </a:r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★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719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099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045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526–0.912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22808834"/>
                  </a:ext>
                </a:extLst>
              </a:tr>
              <a:tr h="130493">
                <a:tc vMerge="1"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DL–</a:t>
                      </a:r>
                      <a:r>
                        <a:rPr lang="en-US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Acetylcarnitine</a:t>
                      </a:r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★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71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11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055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493–0.926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303231740"/>
                  </a:ext>
                </a:extLst>
              </a:tr>
              <a:tr h="130493">
                <a:tc vMerge="1"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–</a:t>
                      </a:r>
                      <a:r>
                        <a:rPr lang="en-US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Monolinolein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319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109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097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106–0.532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901823388"/>
                  </a:ext>
                </a:extLst>
              </a:tr>
              <a:tr h="130493">
                <a:tc rowSpan="20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Negative </a:t>
                      </a:r>
                    </a:p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ion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 mode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Adrenic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 acid</a:t>
                      </a:r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★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981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02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&lt;0.0001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943–1.0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32395101"/>
                  </a:ext>
                </a:extLst>
              </a:tr>
              <a:tr h="130493">
                <a:tc vMerge="1"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Palmitic acid</a:t>
                      </a:r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★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938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06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&lt;0.0001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82–1.0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70194637"/>
                  </a:ext>
                </a:extLst>
              </a:tr>
              <a:tr h="130493">
                <a:tc vMerge="1"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Arachidic acid</a:t>
                      </a:r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★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838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079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002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683–0.993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61437134"/>
                  </a:ext>
                </a:extLst>
              </a:tr>
              <a:tr h="130493">
                <a:tc vMerge="1"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–</a:t>
                      </a:r>
                      <a:r>
                        <a:rPr lang="en-US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Hydroxymyristic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 acid</a:t>
                      </a:r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★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757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095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018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571– 0.943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02948580"/>
                  </a:ext>
                </a:extLst>
              </a:tr>
              <a:tr h="13049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,3,7–</a:t>
                      </a:r>
                      <a:r>
                        <a:rPr lang="en-US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Trimethyluric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 acid</a:t>
                      </a:r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★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748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096</a:t>
                      </a:r>
                      <a:endParaRPr lang="en-US" altLang="zh-CN" sz="800" b="0" i="0" u="none" strike="noStrike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023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56–0.936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1111934"/>
                  </a:ext>
                </a:extLst>
              </a:tr>
              <a:tr h="13049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D–(+)–Glucose</a:t>
                      </a:r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★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738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101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029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541–0.935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61785028"/>
                  </a:ext>
                </a:extLst>
              </a:tr>
              <a:tr h="13049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Lactic Acid</a:t>
                      </a:r>
                    </a:p>
                  </a:txBody>
                  <a:tcPr marL="4763" marR="4763" marT="4763" marB="0" anchor="ctr">
                    <a:lnL w="12700" cmpd="sng">
                      <a:noFill/>
                      <a:prstDash val="soli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69</a:t>
                      </a:r>
                      <a:endParaRPr lang="en-US" altLang="zh-CN" sz="800" b="0" i="0" u="none" strike="noStrike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103</a:t>
                      </a:r>
                      <a:endParaRPr lang="en-US" altLang="zh-CN" sz="800" b="0" i="0" u="none" strike="noStrike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081</a:t>
                      </a:r>
                      <a:endParaRPr lang="en-US" altLang="zh-CN" sz="800" b="0" i="0" u="none" strike="noStrike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489–0.892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21387833"/>
                  </a:ext>
                </a:extLst>
              </a:tr>
              <a:tr h="256223">
                <a:tc vMerge="1"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5alpha–Dihydrotestosterone glucuronide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686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103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089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483–0.888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45997886"/>
                  </a:ext>
                </a:extLst>
              </a:tr>
              <a:tr h="130493">
                <a:tc vMerge="1"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–Methylxanthine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667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104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127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464–0.87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77626571"/>
                  </a:ext>
                </a:extLst>
              </a:tr>
              <a:tr h="13049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3–</a:t>
                      </a:r>
                      <a:r>
                        <a:rPr lang="en-US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Methylglutaric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 acid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605</a:t>
                      </a:r>
                      <a:endParaRPr lang="en-US" altLang="zh-CN" sz="800" b="0" i="0" u="none" strike="noStrike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107</a:t>
                      </a:r>
                      <a:endParaRPr lang="en-US" altLang="zh-CN" sz="800" b="0" i="0" u="none" strike="noStrike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337</a:t>
                      </a:r>
                      <a:endParaRPr lang="en-US" altLang="zh-CN" sz="800" b="0" i="0" u="none" strike="noStrike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396–0.814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09003829"/>
                  </a:ext>
                </a:extLst>
              </a:tr>
              <a:tr h="13049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–Deoxyribose 5–phosphate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581</a:t>
                      </a:r>
                      <a:endParaRPr lang="en-US" altLang="zh-CN" sz="800" b="0" i="0" u="none" strike="noStrike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109</a:t>
                      </a:r>
                      <a:endParaRPr lang="en-US" altLang="zh-CN" sz="800" b="0" i="0" u="none" strike="noStrike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458</a:t>
                      </a:r>
                      <a:endParaRPr lang="en-US" altLang="zh-CN" sz="800" b="0" i="0" u="none" strike="noStrike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368–0.794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44714951"/>
                  </a:ext>
                </a:extLst>
              </a:tr>
              <a:tr h="13049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Prolylglycine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581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109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458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368–0.792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5902983"/>
                  </a:ext>
                </a:extLst>
              </a:tr>
              <a:tr h="130493">
                <a:tc vMerge="1"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Ornithine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51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113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93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287–0.7732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25729027"/>
                  </a:ext>
                </a:extLst>
              </a:tr>
              <a:tr h="13049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Citric acid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481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113</a:t>
                      </a:r>
                      <a:endParaRPr lang="en-US" altLang="zh-CN" sz="800" b="0" i="0" u="none" strike="noStrike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861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259–0.703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57946704"/>
                  </a:ext>
                </a:extLst>
              </a:tr>
              <a:tr h="130493">
                <a:tc vMerge="1"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Nervonic acid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486</a:t>
                      </a:r>
                      <a:endParaRPr lang="en-US" altLang="zh-CN" sz="800" b="0" i="0" u="none" strike="noStrike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112</a:t>
                      </a:r>
                      <a:endParaRPr lang="en-US" altLang="zh-CN" sz="800" b="0" i="0" u="none" strike="noStrike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896</a:t>
                      </a:r>
                      <a:endParaRPr lang="en-US" altLang="zh-CN" sz="800" b="0" i="0" u="none" strike="noStrike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266–0.705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45075641"/>
                  </a:ext>
                </a:extLst>
              </a:tr>
              <a:tr h="13049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D–(+)–Tryptophan</a:t>
                      </a:r>
                    </a:p>
                  </a:txBody>
                  <a:tcPr marL="4763" marR="4763" marT="4763" marB="0" anchor="ctr">
                    <a:lnL w="12700" cmpd="sng">
                      <a:noFill/>
                      <a:prstDash val="soli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419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109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458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205–0.633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61234692"/>
                  </a:ext>
                </a:extLst>
              </a:tr>
              <a:tr h="13049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Uric acid</a:t>
                      </a:r>
                    </a:p>
                  </a:txBody>
                  <a:tcPr marL="4763" marR="4763" marT="4763" marB="0" anchor="ctr">
                    <a:lnL w="12700" cmpd="sng">
                      <a:noFill/>
                      <a:prstDash val="soli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39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107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315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181–0.6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71919116"/>
                  </a:ext>
                </a:extLst>
              </a:tr>
              <a:tr h="13049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Xanthine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352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112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176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133–0.572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76529467"/>
                  </a:ext>
                </a:extLst>
              </a:tr>
              <a:tr h="130493">
                <a:tc vMerge="1"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L–Histidine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343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107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15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134–0.552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42983516"/>
                  </a:ext>
                </a:extLst>
              </a:tr>
              <a:tr h="130493">
                <a:tc vMerge="1"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L–Tyrosine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319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102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097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12–0.518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7488716"/>
                  </a:ext>
                </a:extLst>
              </a:tr>
            </a:tbl>
          </a:graphicData>
        </a:graphic>
      </p:graphicFrame>
      <p:sp>
        <p:nvSpPr>
          <p:cNvPr id="3" name="文本框 2">
            <a:extLst>
              <a:ext uri="{FF2B5EF4-FFF2-40B4-BE49-F238E27FC236}">
                <a16:creationId xmlns:a16="http://schemas.microsoft.com/office/drawing/2014/main" id="{E2F265BD-AA76-A9B6-3A2E-80610E151710}"/>
              </a:ext>
            </a:extLst>
          </p:cNvPr>
          <p:cNvSpPr txBox="1"/>
          <p:nvPr/>
        </p:nvSpPr>
        <p:spPr>
          <a:xfrm>
            <a:off x="280987" y="2594431"/>
            <a:ext cx="6373813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Table S2. ROC analysis of differential serum metabolites detected in positive and negative ion mode.</a:t>
            </a:r>
            <a:endParaRPr lang="zh-CN" altLang="en-US" sz="1350" dirty="0"/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D1481776-6287-E090-70EE-07D3A54CAAA4}"/>
              </a:ext>
            </a:extLst>
          </p:cNvPr>
          <p:cNvSpPr txBox="1"/>
          <p:nvPr/>
        </p:nvSpPr>
        <p:spPr>
          <a:xfrm>
            <a:off x="280987" y="7023000"/>
            <a:ext cx="6134100" cy="7155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Notes: AMD, age–related macular degeneration; ROC, receiver operating characteristic; SVM, support vector machine; AUC, area under the curve; CI, confidence interval.</a:t>
            </a:r>
          </a:p>
        </p:txBody>
      </p:sp>
    </p:spTree>
    <p:extLst>
      <p:ext uri="{BB962C8B-B14F-4D97-AF65-F5344CB8AC3E}">
        <p14:creationId xmlns:p14="http://schemas.microsoft.com/office/powerpoint/2010/main" val="2319411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自定义 1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501</TotalTime>
  <Words>493</Words>
  <Application>Microsoft Office PowerPoint</Application>
  <PresentationFormat>A4 Paper (210x297 mm)</PresentationFormat>
  <Paragraphs>256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等线</vt:lpstr>
      <vt:lpstr>Arial</vt:lpstr>
      <vt:lpstr>Office 主题​​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袁 启娴</dc:creator>
  <cp:lastModifiedBy>Wang BH</cp:lastModifiedBy>
  <cp:revision>110</cp:revision>
  <cp:lastPrinted>2022-12-12T04:21:57Z</cp:lastPrinted>
  <dcterms:created xsi:type="dcterms:W3CDTF">2022-05-19T06:57:21Z</dcterms:created>
  <dcterms:modified xsi:type="dcterms:W3CDTF">2023-06-30T01:20:44Z</dcterms:modified>
</cp:coreProperties>
</file>